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0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A88B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63" autoAdjust="0"/>
    <p:restoredTop sz="96260"/>
  </p:normalViewPr>
  <p:slideViewPr>
    <p:cSldViewPr snapToGrid="0">
      <p:cViewPr varScale="1">
        <p:scale>
          <a:sx n="85" d="100"/>
          <a:sy n="85" d="100"/>
        </p:scale>
        <p:origin x="59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FE5D4F-1226-40F7-8AB0-8498F99D09F2}" type="datetimeFigureOut">
              <a:rPr lang="en-IN" smtClean="0"/>
              <a:t>24-02-2024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00ED42-B4CA-4330-BAA9-605720FA83A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652466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D00ED42-B4CA-4330-BAA9-605720FA83AB}" type="slidenum">
              <a:rPr lang="en-IN" smtClean="0"/>
              <a:t>2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8613559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D00ED42-B4CA-4330-BAA9-605720FA83AB}" type="slidenum">
              <a:rPr lang="en-IN" smtClean="0"/>
              <a:t>3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5766544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D00ED42-B4CA-4330-BAA9-605720FA83AB}" type="slidenum">
              <a:rPr lang="en-IN" smtClean="0"/>
              <a:t>4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51177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4B4C6C-F150-12D1-8798-6D7F95E393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726D48A-1E3D-32FB-3FB8-DF0341A50A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2DF081-D8D8-CDE8-B7A7-8FF6ECB853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6A9AE-C851-413D-BDD0-84D7B5C3BFAC}" type="datetimeFigureOut">
              <a:rPr lang="en-IN" smtClean="0"/>
              <a:t>24-0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D10C10-15E2-FF79-E713-2B58502B2C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F28A2C-740E-5F8E-443E-A869C6E225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B73B-2BE9-4C37-A22E-255C6B4897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69989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8E4D5C-0353-9177-A5A6-12A97BA4EB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32052CF-9C7F-C3B0-50B8-0393E9AB3D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44F8BC-5F00-FCD2-AECD-050E80A5EF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6A9AE-C851-413D-BDD0-84D7B5C3BFAC}" type="datetimeFigureOut">
              <a:rPr lang="en-IN" smtClean="0"/>
              <a:t>24-0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2A8516-E29B-EBD2-55BA-0C5F12A92E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3DCCCB-BDE0-42BE-163A-A09C48BC1E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B73B-2BE9-4C37-A22E-255C6B4897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37830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95554CE-7DF2-CB6F-00FF-1020669023E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E2DE8E6-E582-B9FD-6723-4F5E136683C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2B0CEE-E50C-A22D-9169-5BBAD92D84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6A9AE-C851-413D-BDD0-84D7B5C3BFAC}" type="datetimeFigureOut">
              <a:rPr lang="en-IN" smtClean="0"/>
              <a:t>24-0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3DE735-A92C-2D18-041A-0B582808A0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EC2763-BA65-1D23-32A5-64488126B0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B73B-2BE9-4C37-A22E-255C6B4897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183370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EFB6D8-4E7A-FDB4-DCAD-2E8C7383D3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063796-D238-798B-587A-E8D28F4E681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E1FE7B-6532-787F-D967-E4FA78A9C0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6A9AE-C851-413D-BDD0-84D7B5C3BFAC}" type="datetimeFigureOut">
              <a:rPr lang="en-IN" smtClean="0"/>
              <a:t>24-0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D7B072-037F-92B6-D34A-A63B3065E3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2B445B-33F0-A4B6-07AD-80592FFF6A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B73B-2BE9-4C37-A22E-255C6B4897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174827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8EE011-F5DF-51EF-490E-1656474B3B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359F14-59D9-3286-862F-D67614C61D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EA3E55-6EFA-9521-DAAC-0BDFDC6634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6A9AE-C851-413D-BDD0-84D7B5C3BFAC}" type="datetimeFigureOut">
              <a:rPr lang="en-IN" smtClean="0"/>
              <a:t>24-0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CFFC7E-38F1-9B28-1BF4-55B3525AED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FF72CB-804A-E733-FE13-1590609EEB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B73B-2BE9-4C37-A22E-255C6B4897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628152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2AEE26-3A22-5A1E-36F3-66F6429B78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E86CD2-F94B-F4AB-6893-F2252A87227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5BD12EC-6032-E6A8-1FF2-1598168ADE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2A45DC-4C75-409A-433A-38C1D97EA7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6A9AE-C851-413D-BDD0-84D7B5C3BFAC}" type="datetimeFigureOut">
              <a:rPr lang="en-IN" smtClean="0"/>
              <a:t>24-02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591FF8-AAE3-7C4F-8A68-5A8F6584F5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518B16-8AE9-F3BB-4D80-3301728758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B73B-2BE9-4C37-A22E-255C6B4897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549793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CB5DA2-9F0F-FF14-2B49-15304B65E8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3A4D0C-C97B-A694-5995-154CFA2FFC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B4F09C-A824-E260-5909-0573044C16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FBFFEDD-62D3-102B-7618-5FCEEE190FB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ABC044F-5581-F467-387B-CBC610D2F0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59A8A73-1FFC-2529-B7A6-63EE3B9FE5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6A9AE-C851-413D-BDD0-84D7B5C3BFAC}" type="datetimeFigureOut">
              <a:rPr lang="en-IN" smtClean="0"/>
              <a:t>24-02-2024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538D2D9-55CE-3936-1C91-B960E6662B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285B980-DA66-8140-7FEF-451080E48A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B73B-2BE9-4C37-A22E-255C6B4897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631974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CE3B07-ADE7-74B5-C41A-5A760C06ED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0DBC371-0DFD-001D-65BE-EFA0C79F5B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6A9AE-C851-413D-BDD0-84D7B5C3BFAC}" type="datetimeFigureOut">
              <a:rPr lang="en-IN" smtClean="0"/>
              <a:t>24-02-2024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7CC7A0B-480B-A52F-BB78-8FBC646F65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A312D65-59E9-FC6B-8CE4-19712A0E91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B73B-2BE9-4C37-A22E-255C6B4897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753734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38674A4-C0BD-788B-D48C-BB3D13D18F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6A9AE-C851-413D-BDD0-84D7B5C3BFAC}" type="datetimeFigureOut">
              <a:rPr lang="en-IN" smtClean="0"/>
              <a:t>24-02-2024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2D9C018-5537-237F-0A28-876F75E7DF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D436C25-2F8F-3F9A-E372-5DE6761D3F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B73B-2BE9-4C37-A22E-255C6B4897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665000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8ADA51-8289-D03B-E2FA-502A54C06B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3A6C26-F976-0D07-75FC-C9F6532D1E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E756BFE-AE5A-DEF8-2407-874BE8E62A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17221C4-F959-40B8-6C3C-35F3AFC652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6A9AE-C851-413D-BDD0-84D7B5C3BFAC}" type="datetimeFigureOut">
              <a:rPr lang="en-IN" smtClean="0"/>
              <a:t>24-02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84550E-FC0E-2411-78F8-EBDD9B4AC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89AF38-BC0C-318D-B672-ADAC29E338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B73B-2BE9-4C37-A22E-255C6B4897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76971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5381E2-7D23-5D88-A4CB-30B803C1F8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DF10024-A29D-AA52-74E0-1C79D55763A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C7E3EF-567D-94F2-6E08-FC3A4E1C89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A7CD5E-9C32-6529-CD70-CB12C6D6C5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6A9AE-C851-413D-BDD0-84D7B5C3BFAC}" type="datetimeFigureOut">
              <a:rPr lang="en-IN" smtClean="0"/>
              <a:t>24-02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03F653-7843-2FAE-09B8-2A3732C093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FA5363-089A-28C1-EBF7-EFD30C212F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A1B73B-2BE9-4C37-A22E-255C6B4897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89467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128265F-3DF3-EAE0-8749-CAC9CEAE66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F71845-9C01-202A-46F7-3302A12EEE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774566-30F0-CB0D-0D3A-EA6288DB62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C6A9AE-C851-413D-BDD0-84D7B5C3BFAC}" type="datetimeFigureOut">
              <a:rPr lang="en-IN" smtClean="0"/>
              <a:t>24-0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DCC3DD-E4DD-D37F-8CCC-0C91762501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8158CB-7269-765C-07A5-72F85EB01E3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A1B73B-2BE9-4C37-A22E-255C6B4897F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895300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B436808E-3C60-CED8-5CF4-FF3D8C593A9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204" b="9275"/>
          <a:stretch/>
        </p:blipFill>
        <p:spPr>
          <a:xfrm>
            <a:off x="2799184" y="229541"/>
            <a:ext cx="5654351" cy="6423477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EEDCE77-749D-4BD0-890A-B4F88A5B80D7}"/>
              </a:ext>
            </a:extLst>
          </p:cNvPr>
          <p:cNvSpPr txBox="1"/>
          <p:nvPr/>
        </p:nvSpPr>
        <p:spPr>
          <a:xfrm>
            <a:off x="2322055" y="6556535"/>
            <a:ext cx="78589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lvl="0">
              <a:defRPr lang="en-US"/>
            </a:defPPr>
            <a:lvl1pPr marL="0" lv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lvl="1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lvl="2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lvl="3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lvl="4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lvl="5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lvl="6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lvl="7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lvl="8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Forest plot showing the pooled estimates after removing poor quality studies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35932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5">
            <a:extLst>
              <a:ext uri="{FF2B5EF4-FFF2-40B4-BE49-F238E27FC236}">
                <a16:creationId xmlns:a16="http://schemas.microsoft.com/office/drawing/2014/main" id="{F2D43E97-FE33-6C2D-3E83-C0D2ED3FA6BF}"/>
              </a:ext>
            </a:extLst>
          </p:cNvPr>
          <p:cNvSpPr txBox="1"/>
          <p:nvPr/>
        </p:nvSpPr>
        <p:spPr>
          <a:xfrm>
            <a:off x="3035181" y="6532687"/>
            <a:ext cx="86490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lvl="0">
              <a:defRPr lang="en-US"/>
            </a:defPPr>
            <a:lvl1pPr marL="0" lv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lvl="1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lvl="2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lvl="3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lvl="4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lvl="5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lvl="6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lvl="7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lvl="8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 Influence diagnostics 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DA2EDECE-0AE4-45FE-9553-C791C212B98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5566" y="167967"/>
            <a:ext cx="9400867" cy="62672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37015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5">
            <a:extLst>
              <a:ext uri="{FF2B5EF4-FFF2-40B4-BE49-F238E27FC236}">
                <a16:creationId xmlns:a16="http://schemas.microsoft.com/office/drawing/2014/main" id="{F2D43E97-FE33-6C2D-3E83-C0D2ED3FA6BF}"/>
              </a:ext>
            </a:extLst>
          </p:cNvPr>
          <p:cNvSpPr txBox="1"/>
          <p:nvPr/>
        </p:nvSpPr>
        <p:spPr>
          <a:xfrm>
            <a:off x="3030266" y="6518667"/>
            <a:ext cx="78589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lvl="0">
              <a:defRPr lang="en-US"/>
            </a:defPPr>
            <a:lvl1pPr marL="0" lv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lvl="1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lvl="2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lvl="3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lvl="4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lvl="5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lvl="6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lvl="7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lvl="8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: Forest plot showing the pooled estimates after removing two outlier studies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678764E0-8495-41CF-9603-8B54FE66E81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784" b="8432"/>
          <a:stretch/>
        </p:blipFill>
        <p:spPr>
          <a:xfrm>
            <a:off x="3200401" y="96053"/>
            <a:ext cx="5449078" cy="63663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09189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extBox 5">
            <a:extLst>
              <a:ext uri="{FF2B5EF4-FFF2-40B4-BE49-F238E27FC236}">
                <a16:creationId xmlns:a16="http://schemas.microsoft.com/office/drawing/2014/main" id="{F2D43E97-FE33-6C2D-3E83-C0D2ED3FA6BF}"/>
              </a:ext>
            </a:extLst>
          </p:cNvPr>
          <p:cNvSpPr txBox="1"/>
          <p:nvPr/>
        </p:nvSpPr>
        <p:spPr>
          <a:xfrm>
            <a:off x="3861091" y="6513023"/>
            <a:ext cx="51255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 lvl="0">
              <a:defRPr lang="en-US"/>
            </a:defPPr>
            <a:lvl1pPr marL="0" lv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lvl="1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lvl="2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lvl="3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lvl="4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lvl="5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lvl="6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lvl="7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lvl="8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: Leave one out analysis</a:t>
            </a:r>
            <a:endParaRPr lang="en-IN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2B09920-ACB8-4BA6-A149-77149443B26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8444" y="40031"/>
            <a:ext cx="5600085" cy="64000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64552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61</TotalTime>
  <Words>43</Words>
  <Application>Microsoft Office PowerPoint</Application>
  <PresentationFormat>Widescreen</PresentationFormat>
  <Paragraphs>7</Paragraphs>
  <Slides>4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wan Kumar</dc:creator>
  <cp:lastModifiedBy>Aravind</cp:lastModifiedBy>
  <cp:revision>162</cp:revision>
  <dcterms:created xsi:type="dcterms:W3CDTF">2022-12-29T17:59:47Z</dcterms:created>
  <dcterms:modified xsi:type="dcterms:W3CDTF">2024-02-24T13:24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efa4170-0d19-0005-0004-bc88714345d2_Enabled">
    <vt:lpwstr>true</vt:lpwstr>
  </property>
  <property fmtid="{D5CDD505-2E9C-101B-9397-08002B2CF9AE}" pid="3" name="MSIP_Label_defa4170-0d19-0005-0004-bc88714345d2_SetDate">
    <vt:lpwstr>2023-01-04T17:44:22Z</vt:lpwstr>
  </property>
  <property fmtid="{D5CDD505-2E9C-101B-9397-08002B2CF9AE}" pid="4" name="MSIP_Label_defa4170-0d19-0005-0004-bc88714345d2_Method">
    <vt:lpwstr>Standard</vt:lpwstr>
  </property>
  <property fmtid="{D5CDD505-2E9C-101B-9397-08002B2CF9AE}" pid="5" name="MSIP_Label_defa4170-0d19-0005-0004-bc88714345d2_Name">
    <vt:lpwstr>defa4170-0d19-0005-0004-bc88714345d2</vt:lpwstr>
  </property>
  <property fmtid="{D5CDD505-2E9C-101B-9397-08002B2CF9AE}" pid="6" name="MSIP_Label_defa4170-0d19-0005-0004-bc88714345d2_SiteId">
    <vt:lpwstr>7cd8ab03-1140-439f-bb37-ae413251d439</vt:lpwstr>
  </property>
  <property fmtid="{D5CDD505-2E9C-101B-9397-08002B2CF9AE}" pid="7" name="MSIP_Label_defa4170-0d19-0005-0004-bc88714345d2_ActionId">
    <vt:lpwstr>06876598-b075-4780-a4f0-a506e1fa6def</vt:lpwstr>
  </property>
  <property fmtid="{D5CDD505-2E9C-101B-9397-08002B2CF9AE}" pid="8" name="MSIP_Label_defa4170-0d19-0005-0004-bc88714345d2_ContentBits">
    <vt:lpwstr>0</vt:lpwstr>
  </property>
</Properties>
</file>